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2" d="100"/>
          <a:sy n="122" d="100"/>
        </p:scale>
        <p:origin x="96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9582E8-E787-4D29-A488-B39AE483AF0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1300703-B569-4741-986E-567F128E4FD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658888-DA71-4395-99F2-8ACEB2966A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E2D24-18CD-4098-B043-8F6DC39AA50D}" type="datetimeFigureOut">
              <a:rPr lang="en-AU" smtClean="0"/>
              <a:t>24/02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7FE462-87B5-4C25-A738-C5F691AA29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22DC20-7A20-4825-AFDB-4EC7780018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E531A-9509-47CF-9709-FD5CEE23B76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770344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50A605-7C51-43EE-9368-A366760FC6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F853F1B-839E-4C5E-B9BE-7363D279EB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0E2DD0-1415-430F-BD07-EE00494220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E2D24-18CD-4098-B043-8F6DC39AA50D}" type="datetimeFigureOut">
              <a:rPr lang="en-AU" smtClean="0"/>
              <a:t>24/02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AC98CB-D1E1-46B7-88A4-A1CE8FC69A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41BD3C-F59C-4DA4-AB90-732799493A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E531A-9509-47CF-9709-FD5CEE23B76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774885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E8E54CA-B928-4677-9567-29756CFB22B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D3C6A8B-3135-4408-B134-5E58C14A5DD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A3F1E4-B26F-42F7-8B45-711A52554B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E2D24-18CD-4098-B043-8F6DC39AA50D}" type="datetimeFigureOut">
              <a:rPr lang="en-AU" smtClean="0"/>
              <a:t>24/02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0D9778-29FE-410E-AE77-02954A1762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6DC231-737B-484C-BAA0-0886AC7089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E531A-9509-47CF-9709-FD5CEE23B76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671313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9B6104-3B20-4C1A-85AD-0E5548F24E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C0AE88-CA13-4114-8299-5DC162897CD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BED77F-527D-4D96-BCCF-12E2036563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E2D24-18CD-4098-B043-8F6DC39AA50D}" type="datetimeFigureOut">
              <a:rPr lang="en-AU" smtClean="0"/>
              <a:t>24/02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C62E5C-C6F8-4364-9EC0-3A97BE9197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6AAA31-3560-4DFF-88A1-0AF1E03CF5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E531A-9509-47CF-9709-FD5CEE23B76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968398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996DCC-46D1-46A7-9A25-A0A207BE86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DCBEC0-1310-4563-A5A8-3D0EC93957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1F1911-853B-47CC-B548-1DDEA43EC6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E2D24-18CD-4098-B043-8F6DC39AA50D}" type="datetimeFigureOut">
              <a:rPr lang="en-AU" smtClean="0"/>
              <a:t>24/02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06B5C3-6E24-43C4-B738-DC6B269842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EF295D-4DD6-4EBE-9120-86F5CD35AC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E531A-9509-47CF-9709-FD5CEE23B76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731977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A5B978-9A7C-49BA-B0B6-90F8CB896F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24ECF6-E9BC-480D-93E6-8A4A47997C8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6B695C9-1906-4163-8065-CF87F8BCE4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0058DB-9764-43E5-85FB-FDCB4C11AE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E2D24-18CD-4098-B043-8F6DC39AA50D}" type="datetimeFigureOut">
              <a:rPr lang="en-AU" smtClean="0"/>
              <a:t>24/02/2022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7980F3-C632-4581-876E-8174B5F822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91C22B-1CA0-478C-B1C1-7B9C27E329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E531A-9509-47CF-9709-FD5CEE23B76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966089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F31D72-C1DA-468C-9062-6ACC0D34EE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04C9C3F-69E9-4527-BA94-C5D80847DB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9790C6E-132A-492F-AED9-D53F3C6523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288CE9A-EFA5-43D5-9B08-8B0548DD282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8E22922-8E40-4782-AD1A-14F92FA47B1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93826E2-D739-4E11-804A-06C6C60045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E2D24-18CD-4098-B043-8F6DC39AA50D}" type="datetimeFigureOut">
              <a:rPr lang="en-AU" smtClean="0"/>
              <a:t>24/02/2022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E21433E-D28C-4FB7-A085-7E6A1E1794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1C59665-F535-4430-9DA2-B3DD9704FD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E531A-9509-47CF-9709-FD5CEE23B76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726903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0B3843-BA68-4CC4-8CAE-E3CD0CD558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FE0DA21-3F51-4B0F-B82A-F1A7D2728D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E2D24-18CD-4098-B043-8F6DC39AA50D}" type="datetimeFigureOut">
              <a:rPr lang="en-AU" smtClean="0"/>
              <a:t>24/02/2022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B3301A6-713A-4ED3-9839-097A5C50C7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1A7BE89-B926-487E-8742-3FA86072AE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E531A-9509-47CF-9709-FD5CEE23B76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628223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51E9764-2801-4FDF-A635-42D47D0465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E2D24-18CD-4098-B043-8F6DC39AA50D}" type="datetimeFigureOut">
              <a:rPr lang="en-AU" smtClean="0"/>
              <a:t>24/02/2022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515904F-E4C2-4E0A-BFE2-48938EBAE6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2FEE0E3-4FCB-4ED1-9100-29466B4B53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E531A-9509-47CF-9709-FD5CEE23B76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83132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7D5FF6-365E-495F-9025-3187380712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80B1BB-2D54-4424-ABEE-2997E2D1639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F4147A1-F1AA-4BE9-A4BA-C033D8112E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325E38-D458-415D-8C34-EE03A2FA23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E2D24-18CD-4098-B043-8F6DC39AA50D}" type="datetimeFigureOut">
              <a:rPr lang="en-AU" smtClean="0"/>
              <a:t>24/02/2022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0B32E4-C5C5-4752-B768-DA5F143B3B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A12314-C3F7-4727-94D0-60823A463C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E531A-9509-47CF-9709-FD5CEE23B76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915070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2904B8-17C0-4D55-91BB-6DE21A5BF2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6B47C68-4B52-49A9-9D53-624FCE50E91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2E278F5-B346-4924-A257-E2DE475DB9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4CE8C08-5355-4ECB-AB04-3E8D00F4B8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E2D24-18CD-4098-B043-8F6DC39AA50D}" type="datetimeFigureOut">
              <a:rPr lang="en-AU" smtClean="0"/>
              <a:t>24/02/2022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28817B-97BC-497E-A426-8D27ABD44B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2C6D778-BD21-4831-A568-5B09484A7C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E531A-9509-47CF-9709-FD5CEE23B76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368839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B3C7767-BAF9-4023-9DA7-2B160F8691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F7B18C-CACF-4864-A93A-6EDB548D47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C16909-14B0-4973-B1B7-56C5E375F5E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FE2D24-18CD-4098-B043-8F6DC39AA50D}" type="datetimeFigureOut">
              <a:rPr lang="en-AU" smtClean="0"/>
              <a:t>24/02/2022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56F97E-3B1A-4BF8-B9B4-1BC77D66EA4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51A2D8-7548-4DD3-89EB-DB805D7446C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4E531A-9509-47CF-9709-FD5CEE23B76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472689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F1E5891-862B-4872-8358-EA39ADA88BC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823" t="16462" r="4728" b="32109"/>
          <a:stretch/>
        </p:blipFill>
        <p:spPr>
          <a:xfrm>
            <a:off x="793102" y="1762848"/>
            <a:ext cx="6624736" cy="352697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C4A793E-6E30-4CC9-9C76-6CACAA63A66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983" t="36183" r="42992" b="43874"/>
          <a:stretch/>
        </p:blipFill>
        <p:spPr>
          <a:xfrm rot="10800000">
            <a:off x="7698153" y="1743789"/>
            <a:ext cx="2836985" cy="1367693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FA2EE0E-7062-4A3A-A582-9623B5ABFC0C}"/>
              </a:ext>
            </a:extLst>
          </p:cNvPr>
          <p:cNvSpPr txBox="1"/>
          <p:nvPr/>
        </p:nvSpPr>
        <p:spPr>
          <a:xfrm>
            <a:off x="793101" y="695569"/>
            <a:ext cx="626084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/>
              <a:t>Supplementary Fig. </a:t>
            </a:r>
            <a:r>
              <a:rPr lang="en-AU" dirty="0"/>
              <a:t>S1. a. Wheat spike with central section used for gibberellin and LMA ELISA measurements enclosed by a rectangle. b &amp; c. Spikelets with florets 1 and 2 labelled.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705D5F2-D16E-4E7E-8C85-D239C6E5DC85}"/>
              </a:ext>
            </a:extLst>
          </p:cNvPr>
          <p:cNvSpPr txBox="1"/>
          <p:nvPr/>
        </p:nvSpPr>
        <p:spPr>
          <a:xfrm>
            <a:off x="793102" y="1852246"/>
            <a:ext cx="3948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solidFill>
                  <a:schemeClr val="bg1"/>
                </a:solidFill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0BBAEBE-42E1-4B58-AAC5-FD78869249AA}"/>
              </a:ext>
            </a:extLst>
          </p:cNvPr>
          <p:cNvSpPr txBox="1"/>
          <p:nvPr/>
        </p:nvSpPr>
        <p:spPr>
          <a:xfrm>
            <a:off x="7705969" y="1762848"/>
            <a:ext cx="2969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solidFill>
                  <a:schemeClr val="bg1"/>
                </a:solidFill>
              </a:rPr>
              <a:t>b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A8ED52AD-C83A-46C1-B547-B6E457CDAED5}"/>
              </a:ext>
            </a:extLst>
          </p:cNvPr>
          <p:cNvSpPr/>
          <p:nvPr/>
        </p:nvSpPr>
        <p:spPr>
          <a:xfrm>
            <a:off x="2000738" y="2665046"/>
            <a:ext cx="3634154" cy="1781908"/>
          </a:xfrm>
          <a:prstGeom prst="rect">
            <a:avLst/>
          </a:prstGeom>
          <a:noFill/>
          <a:ln cmpd="thickThin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4C29DE2-D5AB-4A1D-85BE-D694FA0D282B}"/>
              </a:ext>
            </a:extLst>
          </p:cNvPr>
          <p:cNvSpPr txBox="1"/>
          <p:nvPr/>
        </p:nvSpPr>
        <p:spPr>
          <a:xfrm>
            <a:off x="8179515" y="3967417"/>
            <a:ext cx="307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c</a:t>
            </a:r>
          </a:p>
        </p:txBody>
      </p:sp>
      <p:sp>
        <p:nvSpPr>
          <p:cNvPr id="14" name="Oval 13">
            <a:extLst>
              <a:ext uri="{FF2B5EF4-FFF2-40B4-BE49-F238E27FC236}">
                <a16:creationId xmlns:a16="http://schemas.microsoft.com/office/drawing/2014/main" id="{3442513E-F6D9-4E29-891B-A98158EEA37B}"/>
              </a:ext>
            </a:extLst>
          </p:cNvPr>
          <p:cNvSpPr/>
          <p:nvPr/>
        </p:nvSpPr>
        <p:spPr>
          <a:xfrm rot="20144254">
            <a:off x="9154555" y="4671073"/>
            <a:ext cx="618998" cy="355612"/>
          </a:xfrm>
          <a:prstGeom prst="ellipse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C106BD91-7BF0-4E3A-89E8-D5A11FB72B22}"/>
              </a:ext>
            </a:extLst>
          </p:cNvPr>
          <p:cNvSpPr/>
          <p:nvPr/>
        </p:nvSpPr>
        <p:spPr>
          <a:xfrm rot="1750484">
            <a:off x="8508435" y="4881795"/>
            <a:ext cx="689737" cy="355612"/>
          </a:xfrm>
          <a:prstGeom prst="ellipse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7F6ADA0B-466A-4E78-B95A-C9B5581142B1}"/>
              </a:ext>
            </a:extLst>
          </p:cNvPr>
          <p:cNvSpPr/>
          <p:nvPr/>
        </p:nvSpPr>
        <p:spPr>
          <a:xfrm rot="1699448">
            <a:off x="8574640" y="4454293"/>
            <a:ext cx="620794" cy="263062"/>
          </a:xfrm>
          <a:prstGeom prst="ellipse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F3BA767A-2E0E-4FB3-8297-ECCC0B22821A}"/>
              </a:ext>
            </a:extLst>
          </p:cNvPr>
          <p:cNvSpPr/>
          <p:nvPr/>
        </p:nvSpPr>
        <p:spPr>
          <a:xfrm rot="19483246">
            <a:off x="9163416" y="4180478"/>
            <a:ext cx="532742" cy="284579"/>
          </a:xfrm>
          <a:prstGeom prst="ellipse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E4DC6688-FA02-4973-B090-B2AEBCA234BA}"/>
              </a:ext>
            </a:extLst>
          </p:cNvPr>
          <p:cNvCxnSpPr>
            <a:cxnSpLocks/>
            <a:endCxn id="15" idx="6"/>
          </p:cNvCxnSpPr>
          <p:nvPr/>
        </p:nvCxnSpPr>
        <p:spPr>
          <a:xfrm flipH="1" flipV="1">
            <a:off x="9154421" y="5227716"/>
            <a:ext cx="86676" cy="37271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C8920C1D-2F20-4726-8920-62D56760239C}"/>
              </a:ext>
            </a:extLst>
          </p:cNvPr>
          <p:cNvCxnSpPr>
            <a:cxnSpLocks/>
            <a:stCxn id="15" idx="6"/>
            <a:endCxn id="14" idx="2"/>
          </p:cNvCxnSpPr>
          <p:nvPr/>
        </p:nvCxnSpPr>
        <p:spPr>
          <a:xfrm flipV="1">
            <a:off x="9154421" y="4976057"/>
            <a:ext cx="27471" cy="25165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AE21EA14-A2AF-47B8-81B5-0ACD8CD97ECA}"/>
              </a:ext>
            </a:extLst>
          </p:cNvPr>
          <p:cNvCxnSpPr>
            <a:cxnSpLocks/>
            <a:stCxn id="14" idx="2"/>
            <a:endCxn id="16" idx="6"/>
          </p:cNvCxnSpPr>
          <p:nvPr/>
        </p:nvCxnSpPr>
        <p:spPr>
          <a:xfrm flipH="1" flipV="1">
            <a:off x="9158273" y="4733095"/>
            <a:ext cx="23619" cy="2429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E66583B7-B677-4BAD-B5D0-0BD89AD76259}"/>
              </a:ext>
            </a:extLst>
          </p:cNvPr>
          <p:cNvCxnSpPr>
            <a:cxnSpLocks/>
            <a:stCxn id="16" idx="6"/>
          </p:cNvCxnSpPr>
          <p:nvPr/>
        </p:nvCxnSpPr>
        <p:spPr>
          <a:xfrm flipV="1">
            <a:off x="9158273" y="4480369"/>
            <a:ext cx="62406" cy="25272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Arc 32">
            <a:extLst>
              <a:ext uri="{FF2B5EF4-FFF2-40B4-BE49-F238E27FC236}">
                <a16:creationId xmlns:a16="http://schemas.microsoft.com/office/drawing/2014/main" id="{60DB2BF5-ACDF-4129-9BD3-5EEB3BF83AAD}"/>
              </a:ext>
            </a:extLst>
          </p:cNvPr>
          <p:cNvSpPr/>
          <p:nvPr/>
        </p:nvSpPr>
        <p:spPr>
          <a:xfrm rot="9542571">
            <a:off x="8477201" y="4463123"/>
            <a:ext cx="1044393" cy="914400"/>
          </a:xfrm>
          <a:prstGeom prst="arc">
            <a:avLst>
              <a:gd name="adj1" fmla="val 16200000"/>
              <a:gd name="adj2" fmla="val 642411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34" name="Arc 33">
            <a:extLst>
              <a:ext uri="{FF2B5EF4-FFF2-40B4-BE49-F238E27FC236}">
                <a16:creationId xmlns:a16="http://schemas.microsoft.com/office/drawing/2014/main" id="{A15A20FC-8E06-4802-B811-5B24978DDDCB}"/>
              </a:ext>
            </a:extLst>
          </p:cNvPr>
          <p:cNvSpPr/>
          <p:nvPr/>
        </p:nvSpPr>
        <p:spPr>
          <a:xfrm rot="6739618">
            <a:off x="8860519" y="4175471"/>
            <a:ext cx="1104872" cy="954159"/>
          </a:xfrm>
          <a:prstGeom prst="arc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DADF0BA-84D4-4393-9CC5-27E7C98D736F}"/>
              </a:ext>
            </a:extLst>
          </p:cNvPr>
          <p:cNvSpPr txBox="1"/>
          <p:nvPr/>
        </p:nvSpPr>
        <p:spPr>
          <a:xfrm>
            <a:off x="8648670" y="4846509"/>
            <a:ext cx="326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1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E567C10-3E34-499F-BA58-7DFF9834BAEF}"/>
              </a:ext>
            </a:extLst>
          </p:cNvPr>
          <p:cNvSpPr txBox="1"/>
          <p:nvPr/>
        </p:nvSpPr>
        <p:spPr>
          <a:xfrm>
            <a:off x="9346089" y="4676886"/>
            <a:ext cx="154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2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EA4EBDD-37FC-42A2-BCD8-5521DF9A8EE9}"/>
              </a:ext>
            </a:extLst>
          </p:cNvPr>
          <p:cNvSpPr txBox="1"/>
          <p:nvPr/>
        </p:nvSpPr>
        <p:spPr>
          <a:xfrm>
            <a:off x="8465510" y="1399592"/>
            <a:ext cx="1353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Floret 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97B946D-B799-4AF9-8B2A-B2E07C804CF3}"/>
              </a:ext>
            </a:extLst>
          </p:cNvPr>
          <p:cNvSpPr txBox="1"/>
          <p:nvPr/>
        </p:nvSpPr>
        <p:spPr>
          <a:xfrm>
            <a:off x="8487425" y="3138044"/>
            <a:ext cx="13023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Floret 2</a:t>
            </a:r>
          </a:p>
        </p:txBody>
      </p: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8E8E9CC3-3ED6-4A51-893C-87E383353A1F}"/>
              </a:ext>
            </a:extLst>
          </p:cNvPr>
          <p:cNvCxnSpPr>
            <a:stCxn id="37" idx="1"/>
          </p:cNvCxnSpPr>
          <p:nvPr/>
        </p:nvCxnSpPr>
        <p:spPr>
          <a:xfrm flipH="1">
            <a:off x="8179515" y="1584258"/>
            <a:ext cx="285995" cy="452654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748C41B9-94D1-4E4B-B92A-3414CEE03678}"/>
              </a:ext>
            </a:extLst>
          </p:cNvPr>
          <p:cNvCxnSpPr/>
          <p:nvPr/>
        </p:nvCxnSpPr>
        <p:spPr>
          <a:xfrm flipH="1" flipV="1">
            <a:off x="8248261" y="2362752"/>
            <a:ext cx="239164" cy="814722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462971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</TotalTime>
  <Words>45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ryl Mares</dc:creator>
  <cp:lastModifiedBy>Daryl Mares</cp:lastModifiedBy>
  <cp:revision>12</cp:revision>
  <dcterms:created xsi:type="dcterms:W3CDTF">2021-12-04T00:23:28Z</dcterms:created>
  <dcterms:modified xsi:type="dcterms:W3CDTF">2022-02-24T05:40:02Z</dcterms:modified>
</cp:coreProperties>
</file>